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8" d="100"/>
          <a:sy n="58" d="100"/>
        </p:scale>
        <p:origin x="-998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8/12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0" y="908720"/>
            <a:ext cx="2578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Supplementary Figure 1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95536" y="4437112"/>
            <a:ext cx="874846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Supplementary Figure 1: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The expression level of </a:t>
            </a:r>
            <a:r>
              <a:rPr lang="el-GR" altLang="zh-CN" dirty="0" smtClean="0">
                <a:latin typeface="Times New Roman" pitchFamily="18" charset="0"/>
                <a:cs typeface="Times New Roman" pitchFamily="18" charset="0"/>
              </a:rPr>
              <a:t>β-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actin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was similar between male and female.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Western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blot was used to detect the expression levels of β-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actin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, GAPDH, and β-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Tubulin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in liver from female and male mice infected with </a:t>
            </a:r>
            <a:r>
              <a:rPr lang="en-US" altLang="zh-CN" i="1" dirty="0" err="1" smtClean="0">
                <a:latin typeface="Times New Roman" pitchFamily="18" charset="0"/>
                <a:cs typeface="Times New Roman" pitchFamily="18" charset="0"/>
              </a:rPr>
              <a:t>S.japonicum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for 6 weeks. 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 descr="F:\博士阶段20181011备份\数据整理\ACTIN TUBULIN GAPDH比较--未被覆盖\0-14周结果统计\Figure\Supplementary Figure 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95536" y="1772816"/>
            <a:ext cx="8394700" cy="2057400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395536" y="3717032"/>
            <a:ext cx="874846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Supplementary Figure 2: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The expression level of </a:t>
            </a:r>
            <a:r>
              <a:rPr lang="el-GR" altLang="zh-CN" dirty="0" smtClean="0">
                <a:latin typeface="Times New Roman" pitchFamily="18" charset="0"/>
                <a:cs typeface="Times New Roman" pitchFamily="18" charset="0"/>
              </a:rPr>
              <a:t>β-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actin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increased in fibrotic mouse liver induced by CCl4. Western blot was used to detect the expression levels of β-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actin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, GAPDH, and β-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Tubulin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in liver. 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0" y="188640"/>
            <a:ext cx="2578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Supplementary Figure 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 descr="F:\博士阶段201800925备份\数据整理\ACTIN TUBULIN GAPDH比较--未被覆盖\0-14周结果统计\Figure\Supplementary Figure 2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38644" y="1138734"/>
            <a:ext cx="6583766" cy="2002234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</TotalTime>
  <Words>91</Words>
  <Application>Microsoft Office PowerPoint</Application>
  <PresentationFormat>全屏显示(4:3)</PresentationFormat>
  <Paragraphs>4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幻灯片 1</vt:lpstr>
      <vt:lpstr>幻灯片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zhangbeibei</dc:creator>
  <cp:lastModifiedBy>zhangbeibei</cp:lastModifiedBy>
  <cp:revision>6</cp:revision>
  <dcterms:created xsi:type="dcterms:W3CDTF">2018-10-11T03:05:46Z</dcterms:created>
  <dcterms:modified xsi:type="dcterms:W3CDTF">2018-12-20T08:56:38Z</dcterms:modified>
</cp:coreProperties>
</file>